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2D974-BD6E-48C4-AD48-EF8E7C0535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452ED-745C-4A17-80FC-B2275FC6C4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63269-7AA9-4C09-949E-03D52B0C7A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7982F-97B4-41E0-97AB-0A2EA09FFB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64D1C-3F0D-41AB-AD78-45CEBACFD9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D9607-BD9E-4024-BCAD-EF667EF423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F3300-678A-40BD-9D8E-39B2071741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8CC51-F9D6-4149-B4B1-65AE9D9351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1397C-BD10-44A7-9897-7FE3BBF566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50100-E167-4757-9071-658C6D4BB6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A5C86-4ABB-4E98-87FD-1779D5CC25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ABE56-9F7A-4C22-9EA1-6260E4BD72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210F88-A1D8-4FA5-92F4-221E7BB3F02D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3F042B-4FF5-4298-A7F4-EF7C56C2D47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"/>
          <p:cNvSpPr/>
          <p:nvPr/>
        </p:nvSpPr>
        <p:spPr>
          <a:xfrm>
            <a:off x="428760" y="0"/>
            <a:ext cx="4857480" cy="824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418 Articles identifi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406 Database searches (MEDLIN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2 Manual searches (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opics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Orthopaedics&amp; traum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                 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Rheumatology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of th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ochrane database of systematic reviews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ZoneTexte 5"/>
          <p:cNvSpPr/>
          <p:nvPr/>
        </p:nvSpPr>
        <p:spPr>
          <a:xfrm>
            <a:off x="5432040" y="1009800"/>
            <a:ext cx="20613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0 Excluded (duplicate repor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ZoneTexte 6"/>
          <p:cNvSpPr/>
          <p:nvPr/>
        </p:nvSpPr>
        <p:spPr>
          <a:xfrm>
            <a:off x="428760" y="1428840"/>
            <a:ext cx="48574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408 Potentially relevant articles Identified for title and abstract revie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ZoneTexte 7"/>
          <p:cNvSpPr/>
          <p:nvPr/>
        </p:nvSpPr>
        <p:spPr>
          <a:xfrm>
            <a:off x="5429160" y="1643040"/>
            <a:ext cx="3357720" cy="1736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06 Exclud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251 inappopriate study topic or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study desig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8 SRs with no meta-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based on R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1 SRs with full text not availab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via PubM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5 withdrawn S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 IPD meta-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8"/>
          <p:cNvSpPr/>
          <p:nvPr/>
        </p:nvSpPr>
        <p:spPr>
          <a:xfrm>
            <a:off x="428760" y="3357720"/>
            <a:ext cx="48574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02 Identified for full-text revie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9"/>
          <p:cNvSpPr/>
          <p:nvPr/>
        </p:nvSpPr>
        <p:spPr>
          <a:xfrm>
            <a:off x="5429160" y="3616200"/>
            <a:ext cx="335772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6 Exclud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3 SRs with no meta-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based on R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2 Type of studies includ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uncl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                              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 Not in English or Frenc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10"/>
          <p:cNvSpPr/>
          <p:nvPr/>
        </p:nvSpPr>
        <p:spPr>
          <a:xfrm>
            <a:off x="428760" y="5072040"/>
            <a:ext cx="48574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66 Systematic reviews with meta-analysis of aggregated d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1"/>
          <p:cNvSpPr/>
          <p:nvPr/>
        </p:nvSpPr>
        <p:spPr>
          <a:xfrm>
            <a:off x="428760" y="6253200"/>
            <a:ext cx="4857480" cy="45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63 Systematic reviews with meta-analysis of aggregated dat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8 clinical research quest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Connecteur droit avec flèche 16"/>
          <p:cNvCxnSpPr>
            <a:stCxn id="41" idx="2"/>
            <a:endCxn id="43" idx="0"/>
          </p:cNvCxnSpPr>
          <p:nvPr/>
        </p:nvCxnSpPr>
        <p:spPr>
          <a:xfrm>
            <a:off x="2857320" y="824040"/>
            <a:ext cx="360" cy="605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Connecteur droit avec flèche 18"/>
          <p:cNvCxnSpPr>
            <a:stCxn id="43" idx="2"/>
            <a:endCxn id="45" idx="0"/>
          </p:cNvCxnSpPr>
          <p:nvPr/>
        </p:nvCxnSpPr>
        <p:spPr>
          <a:xfrm>
            <a:off x="2857320" y="1705320"/>
            <a:ext cx="360" cy="1652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Connecteur droit avec flèche 21"/>
          <p:cNvCxnSpPr>
            <a:stCxn id="45" idx="2"/>
            <a:endCxn id="47" idx="0"/>
          </p:cNvCxnSpPr>
          <p:nvPr/>
        </p:nvCxnSpPr>
        <p:spPr>
          <a:xfrm>
            <a:off x="2857320" y="3634200"/>
            <a:ext cx="360" cy="1438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2" name="Connecteur droit avec flèche 29"/>
          <p:cNvCxnSpPr>
            <a:stCxn id="47" idx="2"/>
            <a:endCxn id="48" idx="0"/>
          </p:cNvCxnSpPr>
          <p:nvPr/>
        </p:nvCxnSpPr>
        <p:spPr>
          <a:xfrm>
            <a:off x="2857320" y="5348520"/>
            <a:ext cx="360" cy="905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3" name="Connecteur droit avec flèche 32"/>
          <p:cNvCxnSpPr/>
          <p:nvPr/>
        </p:nvCxnSpPr>
        <p:spPr>
          <a:xfrm>
            <a:off x="2857320" y="1143000"/>
            <a:ext cx="25722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4" name="Connecteur droit avec flèche 43"/>
          <p:cNvCxnSpPr/>
          <p:nvPr/>
        </p:nvCxnSpPr>
        <p:spPr>
          <a:xfrm>
            <a:off x="2857320" y="4355640"/>
            <a:ext cx="25722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5" name="Connecteur droit avec flèche 31"/>
          <p:cNvCxnSpPr/>
          <p:nvPr/>
        </p:nvCxnSpPr>
        <p:spPr>
          <a:xfrm>
            <a:off x="2857320" y="5784840"/>
            <a:ext cx="25722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6" name="ZoneTexte 35"/>
          <p:cNvSpPr/>
          <p:nvPr/>
        </p:nvSpPr>
        <p:spPr>
          <a:xfrm>
            <a:off x="5429160" y="5456160"/>
            <a:ext cx="335772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 Exclud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 SRs assessing only surgical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implants from the same laborato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7" name="Connecteur droit avec flèche 25"/>
          <p:cNvCxnSpPr/>
          <p:nvPr/>
        </p:nvCxnSpPr>
        <p:spPr>
          <a:xfrm>
            <a:off x="2857320" y="2499840"/>
            <a:ext cx="25722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8" name="TextBox 19"/>
          <p:cNvSpPr/>
          <p:nvPr/>
        </p:nvSpPr>
        <p:spPr>
          <a:xfrm>
            <a:off x="-1730520" y="577836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1T18:03:28Z</dcterms:created>
  <dc:creator>stagiaire</dc:creator>
  <dc:description/>
  <dc:language>en-US</dc:language>
  <cp:lastModifiedBy>Agnès Dechartres</cp:lastModifiedBy>
  <dcterms:modified xsi:type="dcterms:W3CDTF">2014-11-24T15:57:12Z</dcterms:modified>
  <cp:revision>410</cp:revision>
  <dc:subject/>
  <dc:title>Diapositive 1</dc:title>
</cp:coreProperties>
</file>